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36576000" cy="20574000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85" autoAdjust="0"/>
    <p:restoredTop sz="94660"/>
  </p:normalViewPr>
  <p:slideViewPr>
    <p:cSldViewPr snapToGrid="0">
      <p:cViewPr varScale="1">
        <p:scale>
          <a:sx n="28" d="100"/>
          <a:sy n="28" d="100"/>
        </p:scale>
        <p:origin x="63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72000" y="3367089"/>
            <a:ext cx="274320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572000" y="10806114"/>
            <a:ext cx="27432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271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3820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6174700" y="1095375"/>
            <a:ext cx="7886700" cy="174355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14600" y="1095375"/>
            <a:ext cx="23202900" cy="174355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783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394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95550" y="5129216"/>
            <a:ext cx="315468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95550" y="13768391"/>
            <a:ext cx="315468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>
                    <a:tint val="75000"/>
                  </a:schemeClr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288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14600" y="5476875"/>
            <a:ext cx="155448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16600" y="5476875"/>
            <a:ext cx="155448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960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4" y="1095377"/>
            <a:ext cx="31546800" cy="397668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9366" y="5043489"/>
            <a:ext cx="15473361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519366" y="7515225"/>
            <a:ext cx="15473361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516600" y="5043489"/>
            <a:ext cx="15549564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516600" y="7515225"/>
            <a:ext cx="15549564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4115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958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582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6" y="1371600"/>
            <a:ext cx="11796711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549564" y="2962277"/>
            <a:ext cx="1851660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6" y="6172200"/>
            <a:ext cx="11796711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361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19366" y="1371600"/>
            <a:ext cx="11796711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549564" y="2962277"/>
            <a:ext cx="1851660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19366" y="6172200"/>
            <a:ext cx="11796711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7789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14600" y="1095377"/>
            <a:ext cx="315468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14600" y="5476875"/>
            <a:ext cx="315468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514600" y="19069052"/>
            <a:ext cx="82296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368C5A-736D-4D60-A6C8-C8D70AC27AB6}" type="datetimeFigureOut">
              <a:rPr kumimoji="1" lang="ja-JP" altLang="en-US" smtClean="0"/>
              <a:t>2020/12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2115800" y="19069052"/>
            <a:ext cx="123444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831800" y="19069052"/>
            <a:ext cx="82296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9CDF51-BFAE-45D9-9653-D7FA75E04A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028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kumimoji="1"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kumimoji="1"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図 28">
            <a:extLst>
              <a:ext uri="{FF2B5EF4-FFF2-40B4-BE49-F238E27FC236}">
                <a16:creationId xmlns:a16="http://schemas.microsoft.com/office/drawing/2014/main" id="{9753F681-F4A4-4249-91D9-9F3327AD0A5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605" t="10249" r="4606" b="12826"/>
          <a:stretch/>
        </p:blipFill>
        <p:spPr>
          <a:xfrm>
            <a:off x="3160658" y="4790156"/>
            <a:ext cx="13503429" cy="11316495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37AD36F7-2668-4825-8C95-227F4E7B4CE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422" t="10950" r="4733" b="12125"/>
          <a:stretch/>
        </p:blipFill>
        <p:spPr>
          <a:xfrm>
            <a:off x="20464791" y="4929294"/>
            <a:ext cx="13288494" cy="1125207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B45DB0A-BD5A-4797-A4CC-E862AEC37EED}"/>
              </a:ext>
            </a:extLst>
          </p:cNvPr>
          <p:cNvSpPr txBox="1"/>
          <p:nvPr/>
        </p:nvSpPr>
        <p:spPr>
          <a:xfrm rot="16200000">
            <a:off x="16298598" y="9588199"/>
            <a:ext cx="67805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elative expression 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CCFC697-BB11-4A37-AA42-6E4B158340D7}"/>
              </a:ext>
            </a:extLst>
          </p:cNvPr>
          <p:cNvSpPr txBox="1"/>
          <p:nvPr/>
        </p:nvSpPr>
        <p:spPr>
          <a:xfrm>
            <a:off x="23189097" y="15913145"/>
            <a:ext cx="368565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OX-1-L</a:t>
            </a:r>
          </a:p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 = 31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7F3F222-878D-4548-B9FF-0FD07D457236}"/>
              </a:ext>
            </a:extLst>
          </p:cNvPr>
          <p:cNvSpPr txBox="1"/>
          <p:nvPr/>
        </p:nvSpPr>
        <p:spPr>
          <a:xfrm>
            <a:off x="28907102" y="15913145"/>
            <a:ext cx="346533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OX-1-H</a:t>
            </a:r>
          </a:p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 = 57 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78BF5B5-DF7B-4A99-8F99-2A16D90B404E}"/>
              </a:ext>
            </a:extLst>
          </p:cNvPr>
          <p:cNvSpPr txBox="1"/>
          <p:nvPr/>
        </p:nvSpPr>
        <p:spPr>
          <a:xfrm>
            <a:off x="30392415" y="4060140"/>
            <a:ext cx="34653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i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 =</a:t>
            </a:r>
            <a:r>
              <a:rPr lang="ja-JP" altLang="en-US" sz="4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0.</a:t>
            </a:r>
            <a:r>
              <a:rPr lang="en-US" altLang="ja-JP" sz="4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15</a:t>
            </a:r>
            <a:endParaRPr lang="ja-JP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665C8C2-EEB1-447A-BE35-74FC67AEF8F9}"/>
              </a:ext>
            </a:extLst>
          </p:cNvPr>
          <p:cNvSpPr txBox="1"/>
          <p:nvPr/>
        </p:nvSpPr>
        <p:spPr>
          <a:xfrm rot="16200000">
            <a:off x="-1205583" y="9251765"/>
            <a:ext cx="74534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elative expression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345DF76-2B62-4A20-AF51-CF5B1CC9662B}"/>
              </a:ext>
            </a:extLst>
          </p:cNvPr>
          <p:cNvSpPr txBox="1"/>
          <p:nvPr/>
        </p:nvSpPr>
        <p:spPr>
          <a:xfrm>
            <a:off x="5976002" y="15991859"/>
            <a:ext cx="346533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OX-1-L</a:t>
            </a:r>
          </a:p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 = 31 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B7DAEB4-7187-49ED-B4FF-20AA451B5969}"/>
              </a:ext>
            </a:extLst>
          </p:cNvPr>
          <p:cNvSpPr txBox="1"/>
          <p:nvPr/>
        </p:nvSpPr>
        <p:spPr>
          <a:xfrm>
            <a:off x="11477480" y="15991862"/>
            <a:ext cx="346533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LOX-1-H</a:t>
            </a:r>
          </a:p>
          <a:p>
            <a:pPr algn="ctr"/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 = 57 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371E1CD9-1091-45EE-BE8B-87BB3169FBA6}"/>
              </a:ext>
            </a:extLst>
          </p:cNvPr>
          <p:cNvSpPr txBox="1"/>
          <p:nvPr/>
        </p:nvSpPr>
        <p:spPr>
          <a:xfrm>
            <a:off x="13229406" y="4046709"/>
            <a:ext cx="33032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4800" i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 =</a:t>
            </a:r>
            <a:r>
              <a:rPr lang="ja-JP" altLang="en-US" sz="48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ja-JP" altLang="en-US" sz="4800" dirty="0">
                <a:latin typeface="Arial" panose="020B0604020202020204" pitchFamily="34" charset="0"/>
                <a:cs typeface="Arial" panose="020B0604020202020204" pitchFamily="34" charset="0"/>
              </a:rPr>
              <a:t>0.</a:t>
            </a:r>
            <a:r>
              <a:rPr lang="en-US" altLang="ja-JP" sz="4800" dirty="0">
                <a:latin typeface="Arial" panose="020B0604020202020204" pitchFamily="34" charset="0"/>
                <a:cs typeface="Arial" panose="020B0604020202020204" pitchFamily="34" charset="0"/>
              </a:rPr>
              <a:t>677</a:t>
            </a:r>
            <a:endParaRPr lang="ja-JP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9BFFFBE-9DFF-4C25-8019-0F93478CAF94}"/>
              </a:ext>
            </a:extLst>
          </p:cNvPr>
          <p:cNvSpPr txBox="1"/>
          <p:nvPr/>
        </p:nvSpPr>
        <p:spPr>
          <a:xfrm>
            <a:off x="6519629" y="18189728"/>
            <a:ext cx="7644945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tromal LOX-1 status</a:t>
            </a:r>
          </a:p>
        </p:txBody>
      </p:sp>
      <p:sp>
        <p:nvSpPr>
          <p:cNvPr id="22" name="Text Box 7">
            <a:extLst>
              <a:ext uri="{FF2B5EF4-FFF2-40B4-BE49-F238E27FC236}">
                <a16:creationId xmlns:a16="http://schemas.microsoft.com/office/drawing/2014/main" id="{D70336AD-6042-4946-88CE-A9BBF7F79A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3566" y="956574"/>
            <a:ext cx="13743402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Supplementary Figure 2.</a:t>
            </a:r>
            <a:endParaRPr lang="ja-JP" altLang="en-US" sz="8400" dirty="0"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D35B930-D053-4348-A869-A290FE520C56}"/>
              </a:ext>
            </a:extLst>
          </p:cNvPr>
          <p:cNvSpPr txBox="1"/>
          <p:nvPr/>
        </p:nvSpPr>
        <p:spPr>
          <a:xfrm>
            <a:off x="24587292" y="18204359"/>
            <a:ext cx="7226928" cy="92333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Stromal LOX-1 status</a:t>
            </a:r>
          </a:p>
        </p:txBody>
      </p:sp>
      <p:sp>
        <p:nvSpPr>
          <p:cNvPr id="24" name="テキスト ボックス 49">
            <a:extLst>
              <a:ext uri="{FF2B5EF4-FFF2-40B4-BE49-F238E27FC236}">
                <a16:creationId xmlns:a16="http://schemas.microsoft.com/office/drawing/2014/main" id="{A62B36BC-E121-4054-A316-113F8ED052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8251" y="3728516"/>
            <a:ext cx="784189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a</a:t>
            </a:r>
            <a:endParaRPr lang="ja-JP" altLang="en-US" sz="8400" dirty="0">
              <a:cs typeface="Arial" panose="020B0604020202020204" pitchFamily="34" charset="0"/>
            </a:endParaRPr>
          </a:p>
        </p:txBody>
      </p:sp>
      <p:sp>
        <p:nvSpPr>
          <p:cNvPr id="25" name="テキスト ボックス 51">
            <a:extLst>
              <a:ext uri="{FF2B5EF4-FFF2-40B4-BE49-F238E27FC236}">
                <a16:creationId xmlns:a16="http://schemas.microsoft.com/office/drawing/2014/main" id="{29341DAE-CBEC-462E-BE81-7AFA2D167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626191" y="3728522"/>
            <a:ext cx="1347789" cy="1384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8400" dirty="0">
                <a:cs typeface="Arial" panose="020B0604020202020204" pitchFamily="34" charset="0"/>
              </a:rPr>
              <a:t>b</a:t>
            </a:r>
            <a:endParaRPr lang="ja-JP" altLang="en-US" sz="8400" dirty="0"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0F7D150C-98F4-42E2-92B5-3483F0840473}"/>
              </a:ext>
            </a:extLst>
          </p:cNvPr>
          <p:cNvSpPr/>
          <p:nvPr/>
        </p:nvSpPr>
        <p:spPr>
          <a:xfrm>
            <a:off x="7937336" y="3506144"/>
            <a:ext cx="1877437" cy="9233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IFN-γ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F145666F-B5BD-43A6-96B1-61FD0B2A4D64}"/>
              </a:ext>
            </a:extLst>
          </p:cNvPr>
          <p:cNvSpPr/>
          <p:nvPr/>
        </p:nvSpPr>
        <p:spPr>
          <a:xfrm>
            <a:off x="25929690" y="3580475"/>
            <a:ext cx="1762021" cy="9233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5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IL-10</a:t>
            </a:r>
            <a:endParaRPr lang="ja-JP" altLang="en-US" sz="5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0858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5</TotalTime>
  <Words>40</Words>
  <Application>Microsoft Office PowerPoint</Application>
  <PresentationFormat>ユーザー設定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千佳 片山</dc:creator>
  <cp:lastModifiedBy>千佳 片山</cp:lastModifiedBy>
  <cp:revision>60</cp:revision>
  <cp:lastPrinted>2020-09-17T00:04:43Z</cp:lastPrinted>
  <dcterms:created xsi:type="dcterms:W3CDTF">2020-07-21T00:32:47Z</dcterms:created>
  <dcterms:modified xsi:type="dcterms:W3CDTF">2020-12-06T08:20:32Z</dcterms:modified>
</cp:coreProperties>
</file>